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720" r:id="rId1"/>
  </p:sldMasterIdLst>
  <p:notesMasterIdLst>
    <p:notesMasterId r:id="rId3"/>
  </p:notesMasterIdLst>
  <p:sldIdLst>
    <p:sldId id="294" r:id="rId2"/>
  </p:sldIdLst>
  <p:sldSz cx="7559675" cy="10691813"/>
  <p:notesSz cx="6858000" cy="9144000"/>
  <p:defaultTextStyle>
    <a:defPPr>
      <a:defRPr lang="zh-CN"/>
    </a:defPPr>
    <a:lvl1pPr marL="0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1pPr>
    <a:lvl2pPr marL="477809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2pPr>
    <a:lvl3pPr marL="955618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3pPr>
    <a:lvl4pPr marL="1433427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4pPr>
    <a:lvl5pPr marL="1911237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5pPr>
    <a:lvl6pPr marL="2389046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6pPr>
    <a:lvl7pPr marL="2866855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7pPr>
    <a:lvl8pPr marL="3344664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8pPr>
    <a:lvl9pPr marL="3822473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4D4D4"/>
    <a:srgbClr val="606060"/>
    <a:srgbClr val="C7BD15"/>
    <a:srgbClr val="5E3F3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6927" autoAdjust="0"/>
    <p:restoredTop sz="94660"/>
  </p:normalViewPr>
  <p:slideViewPr>
    <p:cSldViewPr snapToGrid="0">
      <p:cViewPr varScale="1">
        <p:scale>
          <a:sx n="45" d="100"/>
          <a:sy n="45" d="100"/>
        </p:scale>
        <p:origin x="192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D9A1D1-FA4B-4BFE-8CB1-BCF9D3D3172D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A86657-A7F8-4317-B62B-26FBC9188D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66220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1pPr>
    <a:lvl2pPr marL="702351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2pPr>
    <a:lvl3pPr marL="1404701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3pPr>
    <a:lvl4pPr marL="2107052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4pPr>
    <a:lvl5pPr marL="2809403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5pPr>
    <a:lvl6pPr marL="3511753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6pPr>
    <a:lvl7pPr marL="4214104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7pPr>
    <a:lvl8pPr marL="4916454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8pPr>
    <a:lvl9pPr marL="5618805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38388" y="1143000"/>
            <a:ext cx="218122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A86657-A7F8-4317-B62B-26FBC9188DB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44706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4089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9713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3483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424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8803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2450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41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2613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5928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6177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9813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6046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38847" y="1052544"/>
            <a:ext cx="6481079" cy="2205624"/>
            <a:chOff x="538847" y="2645124"/>
            <a:chExt cx="6481079" cy="2205624"/>
          </a:xfrm>
        </p:grpSpPr>
        <p:pic>
          <p:nvPicPr>
            <p:cNvPr id="13" name="图片 12"/>
            <p:cNvPicPr>
              <a:picLocks noChangeAspect="1"/>
            </p:cNvPicPr>
            <p:nvPr/>
          </p:nvPicPr>
          <p:blipFill rotWithShape="1">
            <a:blip r:embed="rId3"/>
            <a:srcRect l="27366" t="14270" r="43218" b="12546"/>
            <a:stretch/>
          </p:blipFill>
          <p:spPr>
            <a:xfrm>
              <a:off x="2150003" y="2649714"/>
              <a:ext cx="1576454" cy="220103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9" name="图片 28"/>
            <p:cNvPicPr>
              <a:picLocks noChangeAspect="1"/>
            </p:cNvPicPr>
            <p:nvPr/>
          </p:nvPicPr>
          <p:blipFill rotWithShape="1">
            <a:blip r:embed="rId4"/>
            <a:srcRect l="27450" t="15009" r="43467" b="15213"/>
            <a:stretch/>
          </p:blipFill>
          <p:spPr>
            <a:xfrm>
              <a:off x="3726810" y="2649715"/>
              <a:ext cx="1634699" cy="220103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1" name="图片 30"/>
            <p:cNvPicPr>
              <a:picLocks noChangeAspect="1"/>
            </p:cNvPicPr>
            <p:nvPr/>
          </p:nvPicPr>
          <p:blipFill rotWithShape="1">
            <a:blip r:embed="rId5"/>
            <a:srcRect l="26699" t="17084" r="43717" b="13584"/>
            <a:stretch/>
          </p:blipFill>
          <p:spPr>
            <a:xfrm>
              <a:off x="5346463" y="2649714"/>
              <a:ext cx="1673463" cy="220103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2" name="图片 21"/>
            <p:cNvPicPr>
              <a:picLocks noChangeAspect="1"/>
            </p:cNvPicPr>
            <p:nvPr/>
          </p:nvPicPr>
          <p:blipFill rotWithShape="1">
            <a:blip r:embed="rId6"/>
            <a:srcRect l="31481" t="20786" r="46183" b="18769"/>
            <a:stretch/>
          </p:blipFill>
          <p:spPr>
            <a:xfrm>
              <a:off x="538886" y="2645511"/>
              <a:ext cx="1601913" cy="2205237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xmlns="" id="{98A4670F-A2AF-4413-8691-DF2F7AE38E8B}"/>
                </a:ext>
              </a:extLst>
            </p:cNvPr>
            <p:cNvSpPr txBox="1"/>
            <p:nvPr/>
          </p:nvSpPr>
          <p:spPr>
            <a:xfrm>
              <a:off x="538847" y="2645124"/>
              <a:ext cx="286087" cy="24098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b="1" dirty="0">
                  <a:solidFill>
                    <a:schemeClr val="bg1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</a:t>
              </a:r>
              <a:endParaRPr lang="zh-CN" altLang="en-US" sz="1000" dirty="0">
                <a:solidFill>
                  <a:schemeClr val="bg1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xmlns="" id="{2264EA60-B72B-42CB-AC68-E016DADC16C0}"/>
                </a:ext>
              </a:extLst>
            </p:cNvPr>
            <p:cNvSpPr txBox="1"/>
            <p:nvPr/>
          </p:nvSpPr>
          <p:spPr>
            <a:xfrm>
              <a:off x="2156666" y="2649444"/>
              <a:ext cx="268870" cy="24098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b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xmlns="" id="{B82115C4-F048-4681-8604-4267F2F526A5}"/>
                </a:ext>
              </a:extLst>
            </p:cNvPr>
            <p:cNvSpPr txBox="1"/>
            <p:nvPr/>
          </p:nvSpPr>
          <p:spPr>
            <a:xfrm>
              <a:off x="3725265" y="2649715"/>
              <a:ext cx="300389" cy="24098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c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xmlns="" id="{B82115C4-F048-4681-8604-4267F2F526A5}"/>
                </a:ext>
              </a:extLst>
            </p:cNvPr>
            <p:cNvSpPr txBox="1"/>
            <p:nvPr/>
          </p:nvSpPr>
          <p:spPr>
            <a:xfrm>
              <a:off x="5348266" y="2649916"/>
              <a:ext cx="300389" cy="24098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d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0" name="文本框 9"/>
          <p:cNvSpPr txBox="1"/>
          <p:nvPr/>
        </p:nvSpPr>
        <p:spPr>
          <a:xfrm>
            <a:off x="482646" y="708660"/>
            <a:ext cx="6611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82646" y="3406688"/>
            <a:ext cx="661157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alculation of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E range indicated by PET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-b: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tial feature of a lesion in CT and PET;</a:t>
            </a:r>
          </a:p>
          <a:p>
            <a:pPr>
              <a:lnSpc>
                <a:spcPct val="150000"/>
              </a:lnSpc>
            </a:pP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: High </a:t>
            </a:r>
            <a:r>
              <a:rPr lang="en-US" altLang="zh-CN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-FDG-uptaking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rea (LME) was drawn to measure area (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using closed polygon;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: Curvy length (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of above area was measured to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alculated the range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sing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/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atio (mm);</a:t>
            </a:r>
          </a:p>
          <a:p>
            <a:pPr>
              <a:lnSpc>
                <a:spcPct val="150000"/>
              </a:lnSpc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xample: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values of this lesion respectively were 14.25 cm</a:t>
            </a:r>
            <a:r>
              <a:rPr lang="en-US" altLang="zh-CN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14.20 cm, and the range was 14.25/14.20 (mm)=10.0 mm.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71223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95</TotalTime>
  <Words>99</Words>
  <Application>Microsoft Office PowerPoint</Application>
  <PresentationFormat>Custom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黑体</vt:lpstr>
      <vt:lpstr>Arial</vt:lpstr>
      <vt:lpstr>Calibri</vt:lpstr>
      <vt:lpstr>Calibri Light</vt:lpstr>
      <vt:lpstr>等线</vt:lpstr>
      <vt:lpstr>等线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lojera, Michelle</cp:lastModifiedBy>
  <cp:revision>119</cp:revision>
  <dcterms:created xsi:type="dcterms:W3CDTF">2021-03-22T09:16:26Z</dcterms:created>
  <dcterms:modified xsi:type="dcterms:W3CDTF">2021-07-19T16:21:57Z</dcterms:modified>
</cp:coreProperties>
</file>